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60" r:id="rId3"/>
  </p:sldIdLst>
  <p:sldSz cx="6480175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0" autoAdjust="0"/>
    <p:restoredTop sz="94660"/>
  </p:normalViewPr>
  <p:slideViewPr>
    <p:cSldViewPr snapToGrid="0">
      <p:cViewPr varScale="1">
        <p:scale>
          <a:sx n="148" d="100"/>
          <a:sy n="148" d="100"/>
        </p:scale>
        <p:origin x="2592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122363"/>
            <a:ext cx="5508149" cy="2387600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3602038"/>
            <a:ext cx="4860131" cy="1655762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1C522-D470-43F2-BAE3-6C749743D456}" type="datetimeFigureOut">
              <a:rPr kumimoji="1" lang="ja-JP" altLang="en-US" smtClean="0"/>
              <a:t>2020/10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27F8D-E224-460C-9988-66BA4B7F4B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80580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1C522-D470-43F2-BAE3-6C749743D456}" type="datetimeFigureOut">
              <a:rPr kumimoji="1" lang="ja-JP" altLang="en-US" smtClean="0"/>
              <a:t>2020/10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27F8D-E224-460C-9988-66BA4B7F4B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0044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365125"/>
            <a:ext cx="1397288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365125"/>
            <a:ext cx="4110861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1C522-D470-43F2-BAE3-6C749743D456}" type="datetimeFigureOut">
              <a:rPr kumimoji="1" lang="ja-JP" altLang="en-US" smtClean="0"/>
              <a:t>2020/10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27F8D-E224-460C-9988-66BA4B7F4B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8816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1C522-D470-43F2-BAE3-6C749743D456}" type="datetimeFigureOut">
              <a:rPr kumimoji="1" lang="ja-JP" altLang="en-US" smtClean="0"/>
              <a:t>2020/10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27F8D-E224-460C-9988-66BA4B7F4B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42036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1709740"/>
            <a:ext cx="5589151" cy="2852737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4589465"/>
            <a:ext cx="5589151" cy="1500187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1C522-D470-43F2-BAE3-6C749743D456}" type="datetimeFigureOut">
              <a:rPr kumimoji="1" lang="ja-JP" altLang="en-US" smtClean="0"/>
              <a:t>2020/10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27F8D-E224-460C-9988-66BA4B7F4B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25316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1825625"/>
            <a:ext cx="2754074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1825625"/>
            <a:ext cx="2754074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1C522-D470-43F2-BAE3-6C749743D456}" type="datetimeFigureOut">
              <a:rPr kumimoji="1" lang="ja-JP" altLang="en-US" smtClean="0"/>
              <a:t>2020/10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27F8D-E224-460C-9988-66BA4B7F4B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27068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365127"/>
            <a:ext cx="5589151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1681163"/>
            <a:ext cx="2741417" cy="823912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2505075"/>
            <a:ext cx="2741417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1681163"/>
            <a:ext cx="2754918" cy="823912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2505075"/>
            <a:ext cx="275491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1C522-D470-43F2-BAE3-6C749743D456}" type="datetimeFigureOut">
              <a:rPr kumimoji="1" lang="ja-JP" altLang="en-US" smtClean="0"/>
              <a:t>2020/10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27F8D-E224-460C-9988-66BA4B7F4B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42634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1C522-D470-43F2-BAE3-6C749743D456}" type="datetimeFigureOut">
              <a:rPr kumimoji="1" lang="ja-JP" altLang="en-US" smtClean="0"/>
              <a:t>2020/10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27F8D-E224-460C-9988-66BA4B7F4B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51052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1C522-D470-43F2-BAE3-6C749743D456}" type="datetimeFigureOut">
              <a:rPr kumimoji="1" lang="ja-JP" altLang="en-US" smtClean="0"/>
              <a:t>2020/10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27F8D-E224-460C-9988-66BA4B7F4B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7770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57200"/>
            <a:ext cx="2090025" cy="1600200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987427"/>
            <a:ext cx="3280589" cy="4873625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057400"/>
            <a:ext cx="2090025" cy="3811588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1C522-D470-43F2-BAE3-6C749743D456}" type="datetimeFigureOut">
              <a:rPr kumimoji="1" lang="ja-JP" altLang="en-US" smtClean="0"/>
              <a:t>2020/10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27F8D-E224-460C-9988-66BA4B7F4B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35717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57200"/>
            <a:ext cx="2090025" cy="1600200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987427"/>
            <a:ext cx="3280589" cy="4873625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057400"/>
            <a:ext cx="2090025" cy="3811588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1C522-D470-43F2-BAE3-6C749743D456}" type="datetimeFigureOut">
              <a:rPr kumimoji="1" lang="ja-JP" altLang="en-US" smtClean="0"/>
              <a:t>2020/10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27F8D-E224-460C-9988-66BA4B7F4B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1307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365127"/>
            <a:ext cx="5589151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1825625"/>
            <a:ext cx="5589151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6356352"/>
            <a:ext cx="145803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61C522-D470-43F2-BAE3-6C749743D456}" type="datetimeFigureOut">
              <a:rPr kumimoji="1" lang="ja-JP" altLang="en-US" smtClean="0"/>
              <a:t>2020/10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6356352"/>
            <a:ext cx="218705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6356352"/>
            <a:ext cx="145803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C27F8D-E224-460C-9988-66BA4B7F4B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4101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kumimoji="1"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図 13" descr="テキスト が含まれている画像&#10;&#10;自動的に生成された説明">
            <a:extLst>
              <a:ext uri="{FF2B5EF4-FFF2-40B4-BE49-F238E27FC236}">
                <a16:creationId xmlns:a16="http://schemas.microsoft.com/office/drawing/2014/main" id="{A9877A2B-1CAA-42CA-8734-DCD03397A44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6210" y="836920"/>
            <a:ext cx="2592079" cy="2592079"/>
          </a:xfrm>
          <a:prstGeom prst="rect">
            <a:avLst/>
          </a:prstGeom>
        </p:spPr>
      </p:pic>
      <p:pic>
        <p:nvPicPr>
          <p:cNvPr id="3" name="図 2" descr="テキスト, 地図 が含まれている画像&#10;&#10;自動的に生成された説明">
            <a:extLst>
              <a:ext uri="{FF2B5EF4-FFF2-40B4-BE49-F238E27FC236}">
                <a16:creationId xmlns:a16="http://schemas.microsoft.com/office/drawing/2014/main" id="{0118A4E9-1B37-4F5B-910A-097D59B4F06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515" y="819393"/>
            <a:ext cx="2609608" cy="2609608"/>
          </a:xfrm>
          <a:prstGeom prst="rect">
            <a:avLst/>
          </a:prstGeom>
        </p:spPr>
      </p:pic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26111FC1-5164-4740-BAA9-9BBB9D281869}"/>
              </a:ext>
            </a:extLst>
          </p:cNvPr>
          <p:cNvSpPr/>
          <p:nvPr/>
        </p:nvSpPr>
        <p:spPr>
          <a:xfrm>
            <a:off x="1667195" y="1190962"/>
            <a:ext cx="121824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edian PFS </a:t>
            </a:r>
          </a:p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3.8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vs.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</a:t>
            </a:r>
          </a:p>
          <a:p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0.008</a:t>
            </a: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84FC4AF3-1F54-4B14-9260-CFAC3201FC6E}"/>
              </a:ext>
            </a:extLst>
          </p:cNvPr>
          <p:cNvSpPr/>
          <p:nvPr/>
        </p:nvSpPr>
        <p:spPr>
          <a:xfrm>
            <a:off x="441960" y="502430"/>
            <a:ext cx="3124200" cy="30777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G8 score ≥14 vs.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&lt;14</a:t>
            </a:r>
            <a:endParaRPr lang="en-US" altLang="ja-JP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0BBBAC0-6D02-4565-95E3-9891EE18197D}"/>
              </a:ext>
            </a:extLst>
          </p:cNvPr>
          <p:cNvSpPr txBox="1"/>
          <p:nvPr/>
        </p:nvSpPr>
        <p:spPr>
          <a:xfrm>
            <a:off x="-1" y="71120"/>
            <a:ext cx="3415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3CC4DDC-C3C8-49F1-8D45-1B9B85D5D028}"/>
              </a:ext>
            </a:extLst>
          </p:cNvPr>
          <p:cNvSpPr txBox="1"/>
          <p:nvPr/>
        </p:nvSpPr>
        <p:spPr>
          <a:xfrm>
            <a:off x="91440" y="467589"/>
            <a:ext cx="350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35A514C-7300-44E8-BEA1-3C5367CD8947}"/>
              </a:ext>
            </a:extLst>
          </p:cNvPr>
          <p:cNvSpPr txBox="1"/>
          <p:nvPr/>
        </p:nvSpPr>
        <p:spPr>
          <a:xfrm>
            <a:off x="3064827" y="493245"/>
            <a:ext cx="350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A83356FB-CF88-4045-97C7-5FC51BB37F8C}"/>
              </a:ext>
            </a:extLst>
          </p:cNvPr>
          <p:cNvSpPr/>
          <p:nvPr/>
        </p:nvSpPr>
        <p:spPr>
          <a:xfrm>
            <a:off x="4698040" y="1190962"/>
            <a:ext cx="121824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edian OS 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9.3 vs. 3.7 M</a:t>
            </a:r>
          </a:p>
          <a:p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0.0028</a:t>
            </a:r>
          </a:p>
        </p:txBody>
      </p:sp>
    </p:spTree>
    <p:extLst>
      <p:ext uri="{BB962C8B-B14F-4D97-AF65-F5344CB8AC3E}">
        <p14:creationId xmlns:p14="http://schemas.microsoft.com/office/powerpoint/2010/main" val="930285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テキスト, 地図 が含まれている画像&#10;&#10;自動的に生成された説明">
            <a:extLst>
              <a:ext uri="{FF2B5EF4-FFF2-40B4-BE49-F238E27FC236}">
                <a16:creationId xmlns:a16="http://schemas.microsoft.com/office/drawing/2014/main" id="{2EB48868-F79E-405A-A947-5AE2EE17668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500" y="803665"/>
            <a:ext cx="2598514" cy="2598514"/>
          </a:xfrm>
          <a:prstGeom prst="rect">
            <a:avLst/>
          </a:prstGeom>
        </p:spPr>
      </p:pic>
      <p:pic>
        <p:nvPicPr>
          <p:cNvPr id="5" name="図 4" descr="文字と写真のスクリーンショット&#10;&#10;自動的に生成された説明">
            <a:extLst>
              <a:ext uri="{FF2B5EF4-FFF2-40B4-BE49-F238E27FC236}">
                <a16:creationId xmlns:a16="http://schemas.microsoft.com/office/drawing/2014/main" id="{B0B220A5-43ED-4DAD-A448-D01533A3FA7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1875" y="803665"/>
            <a:ext cx="2598514" cy="2598514"/>
          </a:xfrm>
          <a:prstGeom prst="rect">
            <a:avLst/>
          </a:prstGeom>
        </p:spPr>
      </p:pic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26111FC1-5164-4740-BAA9-9BBB9D281869}"/>
              </a:ext>
            </a:extLst>
          </p:cNvPr>
          <p:cNvSpPr/>
          <p:nvPr/>
        </p:nvSpPr>
        <p:spPr>
          <a:xfrm>
            <a:off x="1667195" y="1190962"/>
            <a:ext cx="121824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edian PFS 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.0 vs. 2.2 M</a:t>
            </a:r>
          </a:p>
          <a:p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= 0.55</a:t>
            </a: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84FC4AF3-1F54-4B14-9260-CFAC3201FC6E}"/>
              </a:ext>
            </a:extLst>
          </p:cNvPr>
          <p:cNvSpPr/>
          <p:nvPr/>
        </p:nvSpPr>
        <p:spPr>
          <a:xfrm>
            <a:off x="441960" y="502430"/>
            <a:ext cx="3124200" cy="30777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S 0 vs 1-2</a:t>
            </a:r>
            <a:endParaRPr lang="en-US" altLang="ja-JP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0BBBAC0-6D02-4565-95E3-9891EE18197D}"/>
              </a:ext>
            </a:extLst>
          </p:cNvPr>
          <p:cNvSpPr txBox="1"/>
          <p:nvPr/>
        </p:nvSpPr>
        <p:spPr>
          <a:xfrm>
            <a:off x="-1" y="71120"/>
            <a:ext cx="3415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3CC4DDC-C3C8-49F1-8D45-1B9B85D5D028}"/>
              </a:ext>
            </a:extLst>
          </p:cNvPr>
          <p:cNvSpPr txBox="1"/>
          <p:nvPr/>
        </p:nvSpPr>
        <p:spPr>
          <a:xfrm>
            <a:off x="91440" y="467589"/>
            <a:ext cx="350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35A514C-7300-44E8-BEA1-3C5367CD8947}"/>
              </a:ext>
            </a:extLst>
          </p:cNvPr>
          <p:cNvSpPr txBox="1"/>
          <p:nvPr/>
        </p:nvSpPr>
        <p:spPr>
          <a:xfrm>
            <a:off x="3064827" y="493245"/>
            <a:ext cx="350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A83356FB-CF88-4045-97C7-5FC51BB37F8C}"/>
              </a:ext>
            </a:extLst>
          </p:cNvPr>
          <p:cNvSpPr/>
          <p:nvPr/>
        </p:nvSpPr>
        <p:spPr>
          <a:xfrm>
            <a:off x="4402840" y="1190962"/>
            <a:ext cx="121824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edian OS 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8.8 vs. 5.3 M</a:t>
            </a:r>
          </a:p>
          <a:p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= 0.21</a:t>
            </a:r>
          </a:p>
        </p:txBody>
      </p:sp>
    </p:spTree>
    <p:extLst>
      <p:ext uri="{BB962C8B-B14F-4D97-AF65-F5344CB8AC3E}">
        <p14:creationId xmlns:p14="http://schemas.microsoft.com/office/powerpoint/2010/main" val="5125909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21</TotalTime>
  <Words>62</Words>
  <Application>Microsoft Office PowerPoint</Application>
  <PresentationFormat>ユーザー設定</PresentationFormat>
  <Paragraphs>20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雅信 高橋</dc:creator>
  <cp:lastModifiedBy>Masa-XPS</cp:lastModifiedBy>
  <cp:revision>41</cp:revision>
  <dcterms:created xsi:type="dcterms:W3CDTF">2019-04-08T10:23:49Z</dcterms:created>
  <dcterms:modified xsi:type="dcterms:W3CDTF">2020-10-23T01:42:03Z</dcterms:modified>
</cp:coreProperties>
</file>